
<file path=[Content_Types].xml><?xml version="1.0" encoding="utf-8"?>
<Types xmlns="http://schemas.openxmlformats.org/package/2006/content-types">
  <Default Extension="avi" ContentType="video/x-msvideo"/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803" r:id="rId2"/>
    <p:sldId id="799" r:id="rId3"/>
    <p:sldId id="800" r:id="rId4"/>
    <p:sldId id="804" r:id="rId5"/>
    <p:sldId id="794" r:id="rId6"/>
    <p:sldId id="798" r:id="rId7"/>
    <p:sldId id="801" r:id="rId8"/>
    <p:sldId id="802" r:id="rId9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>
      <p:cViewPr>
        <p:scale>
          <a:sx n="69" d="100"/>
          <a:sy n="69" d="100"/>
        </p:scale>
        <p:origin x="3828" y="21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7FD925C-B58E-49BF-8664-45D20079AD4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17C1A30-F47E-4A14-BFCC-756AA92AEF4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151AB10-7611-45A5-A000-7DD41E6F1B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631B19-ECDE-4263-94A7-540E59CDFB55}" type="datetimeFigureOut">
              <a:rPr lang="en-US" smtClean="0"/>
              <a:t>7/1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FD5DF1E-3A9F-4A96-8DBD-F259837960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E049B91-AEC8-4FC1-8272-1A7A7E968D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8FB8C9-25D2-4C14-9264-DA09A80C01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60744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A41B2E-512D-4CBE-B9A7-B6B4F1BC0CC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4962DF8-DCA3-4B9E-B92E-670299ED9CD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F3FBF1B-956B-45E3-A357-9898EF20D3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631B19-ECDE-4263-94A7-540E59CDFB55}" type="datetimeFigureOut">
              <a:rPr lang="en-US" smtClean="0"/>
              <a:t>7/1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5C2AA6C-071E-4AD7-92C3-A77A7D5600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4EDA8F4-85AB-4BF7-A9C0-72094D1A12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8FB8C9-25D2-4C14-9264-DA09A80C01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74043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05404F4-6076-416E-BA33-9D9CD8F0DCB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BC3E6A0-78F8-4B2C-B06B-9736386989C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F3145D6-DCBC-4D63-8BD9-C3BE02E198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631B19-ECDE-4263-94A7-540E59CDFB55}" type="datetimeFigureOut">
              <a:rPr lang="en-US" smtClean="0"/>
              <a:t>7/1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0279CBA-C088-4A0D-BAC1-03EBBFD1D7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FD7994F-AA0B-4CF0-A615-399B27DB8B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8FB8C9-25D2-4C14-9264-DA09A80C01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11129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92E1AD-A808-43FE-BED6-43D981CC0AB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2285B58-7D93-497F-AD99-D87435B9E66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0B1AEEF-1AAA-4DAE-8025-9C0D0D9649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631B19-ECDE-4263-94A7-540E59CDFB55}" type="datetimeFigureOut">
              <a:rPr lang="en-US" smtClean="0"/>
              <a:t>7/1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C25D9A9-3B47-4192-A41E-8F47F0F812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6E990BA-0C0F-4FA2-8A4E-39CE37FB7F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8FB8C9-25D2-4C14-9264-DA09A80C01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84715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68D33C-D082-48B1-8F1C-94E82ED07E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73F3BE0-324F-4A33-A8BA-5E3E2601539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D5350DA-85A5-4143-B0B8-AA94577D22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631B19-ECDE-4263-94A7-540E59CDFB55}" type="datetimeFigureOut">
              <a:rPr lang="en-US" smtClean="0"/>
              <a:t>7/1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52F322A-B8D9-4104-BF7D-6392975E18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1DE654E-9D29-41CC-8109-9D7F20B105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8FB8C9-25D2-4C14-9264-DA09A80C01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84836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A65C29A-DC95-45CE-AF77-D30F0004414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30E8501-939D-42D4-9DD7-2EF0F5D68D2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C2A1A6F-8EB2-4330-9A2A-DCD1C64C242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10A3207-44B6-4307-BEAF-E42C7EA0F8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631B19-ECDE-4263-94A7-540E59CDFB55}" type="datetimeFigureOut">
              <a:rPr lang="en-US" smtClean="0"/>
              <a:t>7/11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CD07F56-8FD4-4358-B60A-FAEC26C6FD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ABFA80D-2733-466F-BE0A-AC489F184B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8FB8C9-25D2-4C14-9264-DA09A80C01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57964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1B24F6-2EBC-49D5-8F42-CD7F1182AB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2F0E084-F2FA-4B7B-89DF-F87EBCB7330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1DE4355-3536-4A45-B26B-7F4415E10E3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3EB9CDA-BBD1-4753-89C0-278A0897C48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1A85726-5C97-4BF6-8A1A-A7D8C3EE91E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A836F3E-7DE0-4B20-BA85-158ACAD23C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631B19-ECDE-4263-94A7-540E59CDFB55}" type="datetimeFigureOut">
              <a:rPr lang="en-US" smtClean="0"/>
              <a:t>7/11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891DBC6-D658-43FF-9880-7DC14ACDAF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5502E4D-83F3-429F-926D-94FC4AD7B4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8FB8C9-25D2-4C14-9264-DA09A80C01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28740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62A6EB-E8BC-4300-9825-6FF0E459697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70F33EC-45EF-4B96-9A3C-48F8BBF8F8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631B19-ECDE-4263-94A7-540E59CDFB55}" type="datetimeFigureOut">
              <a:rPr lang="en-US" smtClean="0"/>
              <a:t>7/11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246B406-632F-44F4-B405-0A4C20A894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C846925-540D-42F0-9C53-D348D0A39D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8FB8C9-25D2-4C14-9264-DA09A80C01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72568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EFA992F-D92E-48EE-A6E0-99405A529D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631B19-ECDE-4263-94A7-540E59CDFB55}" type="datetimeFigureOut">
              <a:rPr lang="en-US" smtClean="0"/>
              <a:t>7/11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2E1E4D2-4A85-4E15-8BC1-6AA37B9911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0F84EB5-84D7-4C01-9DEE-3B1A7705FA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8FB8C9-25D2-4C14-9264-DA09A80C01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73714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E4EFE6C-EA3E-49A2-A5FF-71C866C66BF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FD279AF-8AC0-432C-80C3-9196838BBE3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337584D-3FA5-4727-8613-B90DAEF55F0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9001FC2-7802-4684-B0B1-FF9343A3C3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631B19-ECDE-4263-94A7-540E59CDFB55}" type="datetimeFigureOut">
              <a:rPr lang="en-US" smtClean="0"/>
              <a:t>7/11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0585121-63D6-46FE-A276-44135AAD53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C4E1084-2DCA-4A5D-980F-6093043AF0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8FB8C9-25D2-4C14-9264-DA09A80C01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95345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1B649A9-5EAE-473C-934B-58FF84CD3F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51490D9-C604-414F-A1A2-5383A72F6B3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8D087F4-F4BC-45F6-996A-11978DEDEA1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20335BA-2944-4D63-A186-C9C135DBFF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631B19-ECDE-4263-94A7-540E59CDFB55}" type="datetimeFigureOut">
              <a:rPr lang="en-US" smtClean="0"/>
              <a:t>7/11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E9D863D-3DC6-4FEE-AF0C-FFE218EAFF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BBD50C4-A241-4EE0-A147-7AD42D05BC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8FB8C9-25D2-4C14-9264-DA09A80C01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94910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70B47A7-C86E-4200-B711-D2A612BB02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5485766-DECA-4475-9FAC-709A804CA93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B3BE012-3EEC-44AF-8A2C-EA90622E601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631B19-ECDE-4263-94A7-540E59CDFB55}" type="datetimeFigureOut">
              <a:rPr lang="en-US" smtClean="0"/>
              <a:t>7/1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8434CB6-CB88-488D-901D-71AB6DCDBC7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9DEC524-CC7E-4525-8AA9-440557E3500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8FB8C9-25D2-4C14-9264-DA09A80C01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54193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1.avi"/><Relationship Id="rId1" Type="http://schemas.microsoft.com/office/2007/relationships/media" Target="../media/media1.avi"/><Relationship Id="rId4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2.avi"/><Relationship Id="rId1" Type="http://schemas.microsoft.com/office/2007/relationships/media" Target="../media/media2.avi"/><Relationship Id="rId4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3.avi"/><Relationship Id="rId1" Type="http://schemas.microsoft.com/office/2007/relationships/media" Target="../media/media3.avi"/><Relationship Id="rId4" Type="http://schemas.openxmlformats.org/officeDocument/2006/relationships/image" Target="../media/image3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2.avi"/><Relationship Id="rId1" Type="http://schemas.microsoft.com/office/2007/relationships/media" Target="../media/media2.avi"/><Relationship Id="rId4" Type="http://schemas.openxmlformats.org/officeDocument/2006/relationships/image" Target="../media/image2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4.avi"/><Relationship Id="rId1" Type="http://schemas.microsoft.com/office/2007/relationships/media" Target="../media/media4.avi"/><Relationship Id="rId4" Type="http://schemas.openxmlformats.org/officeDocument/2006/relationships/image" Target="../media/image4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5.mp4"/><Relationship Id="rId1" Type="http://schemas.microsoft.com/office/2007/relationships/media" Target="../media/media5.mp4"/><Relationship Id="rId4" Type="http://schemas.openxmlformats.org/officeDocument/2006/relationships/image" Target="../media/image5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6.avi"/><Relationship Id="rId1" Type="http://schemas.microsoft.com/office/2007/relationships/media" Target="../media/media6.avi"/><Relationship Id="rId4" Type="http://schemas.openxmlformats.org/officeDocument/2006/relationships/image" Target="../media/image6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7.avi"/><Relationship Id="rId1" Type="http://schemas.microsoft.com/office/2007/relationships/media" Target="../media/media7.avi"/><Relationship Id="rId4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N2 D3 of adulthood">
            <a:hlinkClick r:id="" action="ppaction://media"/>
            <a:extLst>
              <a:ext uri="{FF2B5EF4-FFF2-40B4-BE49-F238E27FC236}">
                <a16:creationId xmlns:a16="http://schemas.microsoft.com/office/drawing/2014/main" id="{A638EE39-793D-7676-FE7C-CFB2D45ADF72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830974" y="1768581"/>
            <a:ext cx="10977350" cy="448263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A8CD5741-71C2-4CB0-A657-35A7566D23C6}"/>
              </a:ext>
            </a:extLst>
          </p:cNvPr>
          <p:cNvSpPr txBox="1"/>
          <p:nvPr/>
        </p:nvSpPr>
        <p:spPr>
          <a:xfrm>
            <a:off x="196971" y="751759"/>
            <a:ext cx="682266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600" b="1" i="0" baseline="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Day 3 (</a:t>
            </a:r>
            <a:r>
              <a:rPr lang="en-US" sz="3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2)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E6A33BF-D039-4BDD-87CB-90CE71622AAB}"/>
              </a:ext>
            </a:extLst>
          </p:cNvPr>
          <p:cNvSpPr txBox="1"/>
          <p:nvPr/>
        </p:nvSpPr>
        <p:spPr>
          <a:xfrm>
            <a:off x="196971" y="126712"/>
            <a:ext cx="548991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600" b="1" i="0" baseline="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Movie S1</a:t>
            </a:r>
            <a:endParaRPr lang="en-US" sz="3600" dirty="0"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031773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4714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</p:childTnLst>
        </p:cTn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UA196 + 100uM NS132 avi">
            <a:hlinkClick r:id="" action="ppaction://media"/>
            <a:extLst>
              <a:ext uri="{FF2B5EF4-FFF2-40B4-BE49-F238E27FC236}">
                <a16:creationId xmlns:a16="http://schemas.microsoft.com/office/drawing/2014/main" id="{B7FA414F-6628-4866-8B5A-87663267C560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1314215" y="1874982"/>
            <a:ext cx="10562361" cy="4313168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0441FF3A-FDF4-4518-8DD4-8D8DFC58ED93}"/>
              </a:ext>
            </a:extLst>
          </p:cNvPr>
          <p:cNvSpPr txBox="1"/>
          <p:nvPr/>
        </p:nvSpPr>
        <p:spPr>
          <a:xfrm>
            <a:off x="240145" y="833323"/>
            <a:ext cx="682266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600" b="1" i="0" baseline="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Day 3 (</a:t>
            </a:r>
            <a:r>
              <a:rPr lang="en-US" sz="3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UA196)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169B910F-DD5E-44CD-8E15-B7874A05980A}"/>
              </a:ext>
            </a:extLst>
          </p:cNvPr>
          <p:cNvSpPr txBox="1"/>
          <p:nvPr/>
        </p:nvSpPr>
        <p:spPr>
          <a:xfrm>
            <a:off x="240145" y="192126"/>
            <a:ext cx="548991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600" b="1" i="0" baseline="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Movie S2</a:t>
            </a:r>
            <a:endParaRPr lang="en-US" sz="3600" dirty="0"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51108516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5428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3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3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3"/>
                  </p:tgtEl>
                </p:cond>
              </p:nextCondLst>
            </p:seq>
          </p:childTnLst>
        </p:cTn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UA196 + NS163 avi">
            <a:hlinkClick r:id="" action="ppaction://media"/>
            <a:extLst>
              <a:ext uri="{FF2B5EF4-FFF2-40B4-BE49-F238E27FC236}">
                <a16:creationId xmlns:a16="http://schemas.microsoft.com/office/drawing/2014/main" id="{8037B919-E595-4219-8800-C149951F3108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1159303" y="1828800"/>
            <a:ext cx="10747507" cy="4388773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BED3A875-5BF6-4940-AD90-71C3A2EDCD8F}"/>
              </a:ext>
            </a:extLst>
          </p:cNvPr>
          <p:cNvSpPr txBox="1"/>
          <p:nvPr/>
        </p:nvSpPr>
        <p:spPr>
          <a:xfrm>
            <a:off x="196971" y="773043"/>
            <a:ext cx="682266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600" b="1" i="0" baseline="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Day 3 (</a:t>
            </a:r>
            <a:r>
              <a:rPr lang="en-US" sz="3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UA196 + 50 </a:t>
            </a:r>
            <a:r>
              <a:rPr lang="en-US" sz="3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μM</a:t>
            </a:r>
            <a:r>
              <a:rPr lang="en-US" sz="3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S163)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C837829-9752-4C97-833C-5361F2D2E394}"/>
              </a:ext>
            </a:extLst>
          </p:cNvPr>
          <p:cNvSpPr txBox="1"/>
          <p:nvPr/>
        </p:nvSpPr>
        <p:spPr>
          <a:xfrm>
            <a:off x="196971" y="126712"/>
            <a:ext cx="548991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600" b="1" i="0" baseline="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Movie S3</a:t>
            </a:r>
            <a:endParaRPr lang="en-US" sz="3600" dirty="0"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4807143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5285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3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3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3"/>
                  </p:tgtEl>
                </p:cond>
              </p:nextCondLst>
            </p:seq>
          </p:childTnLst>
        </p:cTn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UA196 + 100uM NS132 avi">
            <a:hlinkClick r:id="" action="ppaction://media"/>
            <a:extLst>
              <a:ext uri="{FF2B5EF4-FFF2-40B4-BE49-F238E27FC236}">
                <a16:creationId xmlns:a16="http://schemas.microsoft.com/office/drawing/2014/main" id="{B7FA414F-6628-4866-8B5A-87663267C560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906021" y="1930400"/>
            <a:ext cx="10585500" cy="4322617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86BE135F-2A51-4738-A410-94965ED8EF31}"/>
              </a:ext>
            </a:extLst>
          </p:cNvPr>
          <p:cNvSpPr txBox="1"/>
          <p:nvPr/>
        </p:nvSpPr>
        <p:spPr>
          <a:xfrm>
            <a:off x="132316" y="72053"/>
            <a:ext cx="212135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600" b="1" i="0" baseline="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Movie S4</a:t>
            </a:r>
            <a:endParaRPr lang="en-US" sz="3600" dirty="0"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F277DB6B-3BB3-4745-9BE8-9EBDE5C2EEAD}"/>
              </a:ext>
            </a:extLst>
          </p:cNvPr>
          <p:cNvSpPr txBox="1"/>
          <p:nvPr/>
        </p:nvSpPr>
        <p:spPr>
          <a:xfrm>
            <a:off x="132316" y="604983"/>
            <a:ext cx="682266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600" b="1" i="0" baseline="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Day 3 (</a:t>
            </a:r>
            <a:r>
              <a:rPr lang="en-US" sz="3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UA196 + 50 </a:t>
            </a:r>
            <a:r>
              <a:rPr lang="en-US" sz="3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μM</a:t>
            </a:r>
            <a:r>
              <a:rPr lang="en-US" sz="3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S132)</a:t>
            </a:r>
          </a:p>
        </p:txBody>
      </p:sp>
    </p:spTree>
    <p:extLst>
      <p:ext uri="{BB962C8B-B14F-4D97-AF65-F5344CB8AC3E}">
        <p14:creationId xmlns:p14="http://schemas.microsoft.com/office/powerpoint/2010/main" val="1019711377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5428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3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3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3"/>
                  </p:tgtEl>
                </p:cond>
              </p:nextCondLst>
            </p:seq>
          </p:childTnLst>
        </p:cTn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B04BB214-9020-4D68-88BF-4152AC5533A5}"/>
              </a:ext>
            </a:extLst>
          </p:cNvPr>
          <p:cNvSpPr txBox="1"/>
          <p:nvPr/>
        </p:nvSpPr>
        <p:spPr>
          <a:xfrm>
            <a:off x="182650" y="723004"/>
            <a:ext cx="548991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600" b="1" i="0" baseline="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Day 10 (N2)</a:t>
            </a:r>
            <a:endParaRPr lang="en-US" sz="3600" dirty="0"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E5D77471-E0AC-42A7-A7C7-6ABEE5F99126}"/>
              </a:ext>
            </a:extLst>
          </p:cNvPr>
          <p:cNvSpPr txBox="1"/>
          <p:nvPr/>
        </p:nvSpPr>
        <p:spPr>
          <a:xfrm>
            <a:off x="182650" y="76673"/>
            <a:ext cx="548991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600" b="1" i="0" baseline="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Movie S5</a:t>
            </a:r>
            <a:endParaRPr lang="en-US" sz="3600" dirty="0"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N2 Day 7 of adulthood CTX video">
            <a:hlinkClick r:id="" action="ppaction://media"/>
            <a:extLst>
              <a:ext uri="{FF2B5EF4-FFF2-40B4-BE49-F238E27FC236}">
                <a16:creationId xmlns:a16="http://schemas.microsoft.com/office/drawing/2014/main" id="{782CB228-1FA4-3628-707F-A44EBC646E93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1274618" y="1810327"/>
            <a:ext cx="10686355" cy="436380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5280395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4142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</p:childTnLst>
        </p:cTn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D7 CTX of UA196 + OP50 &amp; EtOH">
            <a:hlinkClick r:id="" action="ppaction://media"/>
            <a:extLst>
              <a:ext uri="{FF2B5EF4-FFF2-40B4-BE49-F238E27FC236}">
                <a16:creationId xmlns:a16="http://schemas.microsoft.com/office/drawing/2014/main" id="{052145C6-0F06-DCE7-189F-A429C98EE090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3705965" y="2095772"/>
            <a:ext cx="5050108" cy="4102287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B7507C77-A32D-4540-B194-5E189935038F}"/>
              </a:ext>
            </a:extLst>
          </p:cNvPr>
          <p:cNvSpPr txBox="1"/>
          <p:nvPr/>
        </p:nvSpPr>
        <p:spPr>
          <a:xfrm>
            <a:off x="182650" y="723004"/>
            <a:ext cx="548991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600" b="1" i="0" baseline="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Day 10 (UA196)</a:t>
            </a:r>
            <a:endParaRPr lang="en-US" sz="3600" dirty="0"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3107E193-C270-4D97-B170-4E357C179088}"/>
              </a:ext>
            </a:extLst>
          </p:cNvPr>
          <p:cNvSpPr txBox="1"/>
          <p:nvPr/>
        </p:nvSpPr>
        <p:spPr>
          <a:xfrm>
            <a:off x="182650" y="76673"/>
            <a:ext cx="548991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600" b="1" i="0" baseline="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Movie S6</a:t>
            </a:r>
            <a:endParaRPr lang="en-US" sz="3600" dirty="0"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9258020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5714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seq concurrent="1" nextAc="seek">
              <p:cTn id="7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8" fill="hold">
                      <p:stCondLst>
                        <p:cond delay="0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1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  <p:video>
              <p:cMediaNode vol="80000">
                <p:cTn id="12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</p:childTnLst>
        </p:cTn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UA196 + 100uM NS163 avi">
            <a:hlinkClick r:id="" action="ppaction://media"/>
            <a:extLst>
              <a:ext uri="{FF2B5EF4-FFF2-40B4-BE49-F238E27FC236}">
                <a16:creationId xmlns:a16="http://schemas.microsoft.com/office/drawing/2014/main" id="{C1D3273F-5D3B-4262-B178-46A36962FA82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915867" y="1891433"/>
            <a:ext cx="10269369" cy="4193524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F5CB378C-D5CA-47FB-B2AD-C6CB77B6CBF9}"/>
              </a:ext>
            </a:extLst>
          </p:cNvPr>
          <p:cNvSpPr txBox="1"/>
          <p:nvPr/>
        </p:nvSpPr>
        <p:spPr>
          <a:xfrm>
            <a:off x="196971" y="773043"/>
            <a:ext cx="682266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600" b="1" i="0" baseline="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Day 10 (</a:t>
            </a:r>
            <a:r>
              <a:rPr lang="en-US" sz="3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UA196 + 50 </a:t>
            </a:r>
            <a:r>
              <a:rPr lang="en-US" sz="3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μM</a:t>
            </a:r>
            <a:r>
              <a:rPr lang="en-US" sz="3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S163)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B58BA563-20DB-4FC2-995B-00B29388E220}"/>
              </a:ext>
            </a:extLst>
          </p:cNvPr>
          <p:cNvSpPr txBox="1"/>
          <p:nvPr/>
        </p:nvSpPr>
        <p:spPr>
          <a:xfrm>
            <a:off x="196971" y="126712"/>
            <a:ext cx="548991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600" b="1" i="0" baseline="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Movie S7</a:t>
            </a:r>
            <a:endParaRPr lang="en-US" sz="3600" dirty="0"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6915048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5428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</p:childTnLst>
        </p:cTn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UA196 + 100uM NS132 avi">
            <a:hlinkClick r:id="" action="ppaction://media"/>
            <a:extLst>
              <a:ext uri="{FF2B5EF4-FFF2-40B4-BE49-F238E27FC236}">
                <a16:creationId xmlns:a16="http://schemas.microsoft.com/office/drawing/2014/main" id="{1548244E-3FBE-4518-8E12-2580D2C97C10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1531245" y="1930400"/>
            <a:ext cx="10359935" cy="4230507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CB4DBB76-8D61-4DB5-A14A-1C4FABDE633C}"/>
              </a:ext>
            </a:extLst>
          </p:cNvPr>
          <p:cNvSpPr txBox="1"/>
          <p:nvPr/>
        </p:nvSpPr>
        <p:spPr>
          <a:xfrm>
            <a:off x="252389" y="782280"/>
            <a:ext cx="682266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600" b="1" i="0" baseline="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Day 10 (</a:t>
            </a:r>
            <a:r>
              <a:rPr lang="en-US" sz="3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UA196 + 50 </a:t>
            </a:r>
            <a:r>
              <a:rPr lang="en-US" sz="3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μM</a:t>
            </a:r>
            <a:r>
              <a:rPr lang="en-US" sz="3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S132)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DA258B9-6E68-4A1A-B420-502D721B9107}"/>
              </a:ext>
            </a:extLst>
          </p:cNvPr>
          <p:cNvSpPr txBox="1"/>
          <p:nvPr/>
        </p:nvSpPr>
        <p:spPr>
          <a:xfrm>
            <a:off x="252389" y="135949"/>
            <a:ext cx="548991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600" b="1" i="0" baseline="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Movie S8</a:t>
            </a:r>
            <a:endParaRPr lang="en-US" sz="3600" dirty="0"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92829966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4000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3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3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3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42</TotalTime>
  <Words>72</Words>
  <Application>Microsoft Office PowerPoint</Application>
  <PresentationFormat>Widescreen</PresentationFormat>
  <Paragraphs>16</Paragraphs>
  <Slides>8</Slides>
  <Notes>0</Notes>
  <HiddenSlides>0</HiddenSlides>
  <MMClips>8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3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Chemotaxis Assay  for UA196 and N2 strains of C. elegans  in the presence of OP50 and EtOH</dc:title>
  <dc:creator>Johnson Joseph</dc:creator>
  <cp:lastModifiedBy>Sunil Kumar</cp:lastModifiedBy>
  <cp:revision>20</cp:revision>
  <dcterms:created xsi:type="dcterms:W3CDTF">2022-04-10T17:32:16Z</dcterms:created>
  <dcterms:modified xsi:type="dcterms:W3CDTF">2022-07-11T22:06:58Z</dcterms:modified>
</cp:coreProperties>
</file>